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1B8D7-5B4E-46CD-A07F-A7C565987E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27B04-7CD3-4990-A3AF-32AC271EF9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EF4951-DC6B-4C20-BEA7-6CF5856A49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3E4460-0E76-45BA-8DEC-AD29BCF68CE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B6D689F-EAA4-4CC5-AE5B-303E682EA2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5D344B-722C-4AF6-A568-14EF1F5E36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135CE56-FA6B-40D9-AF6B-B93755FB2A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73EF36C-7BBA-46D2-86EC-3D854A2A4C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E2B0835-9EB7-4C20-B5A3-10A5F503CB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8C89B10-92B1-4782-BBBA-D1F14008CD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8F19DCC-2AB0-4AE1-8188-38AF44E82C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1FFAC-7586-4B54-9A81-B060722084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3DD402-25DE-4A2B-9438-0601DEA79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A0F8F1-13B3-42A5-96E7-9F9AB94995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7CC2485-A8A0-4BB4-A0E0-5B31EAAAF8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3094469-B906-4843-9584-4353670EB8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8013CD-7F34-40F5-A8B1-DEDFB3FC91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3D1E7D-A243-47F1-8899-A582A885B8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EB2B3-DE33-496F-9709-969FA59ECD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CC92C-AA4C-49D1-9B28-DCF9C588E8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84CDA-0D0A-4DFB-AB7E-F237483D88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47A5B-17C7-4E75-8189-768EBE6C92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B7452-F934-4C4B-ACA9-B8A2BA8D83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EDFDA-169B-4A25-9EE8-0684DDD856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17EB2F-885C-4A17-9D2E-F0B49F08AF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F879AA-A00A-4068-9608-D4FEB02CF42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0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0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0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0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0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0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0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0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with the axis indicating the amount of variance in each component as a percentage of the total. Organ section is indicated by marker colors, lab by marker shapes and gender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shown in different colors and gender is shown by different shape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 different colors and gender is shown by different shape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1371600" y="152280"/>
            <a:ext cx="6400800" cy="4800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dicated by marker color, diet is shown in marker shape and fasting is indicated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1371600" y="304920"/>
            <a:ext cx="6197760" cy="4647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dicated by marker color, diet is shown in marker shape and fasting is indicated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dicated by marker color, gender is shown in marker shape and fasting is indicated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dicated by marker color, diet is shown in marker shape and fasting is indicated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/>
          </p:nvPr>
        </p:nvSpPr>
        <p:spPr>
          <a:xfrm>
            <a:off x="457200" y="5028840"/>
            <a:ext cx="8229600" cy="1577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rincipal components were computed for normalized intensities from samples of the given tissue-chip combination. The first two principal components are shown in the plot with the axis indicating the amount of variance in each component as a percentage of the total. Lab is indicated by marker color, gender is shown in marker shape and fasting is indicated by marker size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" descr=""/>
          <p:cNvPicPr/>
          <p:nvPr/>
        </p:nvPicPr>
        <p:blipFill>
          <a:blip r:embed="rId1"/>
          <a:stretch/>
        </p:blipFill>
        <p:spPr>
          <a:xfrm>
            <a:off x="1473120" y="152280"/>
            <a:ext cx="6197760" cy="464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3T19:45:25Z</dcterms:created>
  <dc:creator>Mike Boedigheimer</dc:creator>
  <dc:description/>
  <dc:language>en-US</dc:language>
  <cp:lastModifiedBy>FDA User</cp:lastModifiedBy>
  <dcterms:modified xsi:type="dcterms:W3CDTF">2007-10-29T18:45:21Z</dcterms:modified>
  <cp:revision>9</cp:revision>
  <dc:subject/>
  <dc:title>Slide 1</dc:title>
</cp:coreProperties>
</file>